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256" r:id="rId2"/>
    <p:sldId id="257" r:id="rId3"/>
    <p:sldId id="258" r:id="rId4"/>
    <p:sldId id="259" r:id="rId5"/>
    <p:sldId id="261" r:id="rId6"/>
    <p:sldId id="262" r:id="rId7"/>
    <p:sldId id="266" r:id="rId8"/>
    <p:sldId id="267" r:id="rId9"/>
  </p:sldIdLst>
  <p:sldSz cx="6858000" cy="9906000" type="A4"/>
  <p:notesSz cx="9236075" cy="7010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856" autoAdjust="0"/>
  </p:normalViewPr>
  <p:slideViewPr>
    <p:cSldViewPr snapToGrid="0" showGuides="1">
      <p:cViewPr varScale="1">
        <p:scale>
          <a:sx n="54" d="100"/>
          <a:sy n="54" d="100"/>
        </p:scale>
        <p:origin x="2630" y="77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002299" cy="351737"/>
          </a:xfrm>
          <a:prstGeom prst="rect">
            <a:avLst/>
          </a:prstGeom>
        </p:spPr>
        <p:txBody>
          <a:bodyPr vert="horz" lIns="92830" tIns="46415" rIns="92830" bIns="4641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31639" y="1"/>
            <a:ext cx="4002299" cy="351737"/>
          </a:xfrm>
          <a:prstGeom prst="rect">
            <a:avLst/>
          </a:prstGeom>
        </p:spPr>
        <p:txBody>
          <a:bodyPr vert="horz" lIns="92830" tIns="46415" rIns="92830" bIns="46415" rtlCol="0"/>
          <a:lstStyle>
            <a:lvl1pPr algn="r">
              <a:defRPr sz="1200"/>
            </a:lvl1pPr>
          </a:lstStyle>
          <a:p>
            <a:fld id="{9245DD46-4992-408B-A3B3-2C98B7817D96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00475" y="876300"/>
            <a:ext cx="1635125" cy="2365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830" tIns="46415" rIns="92830" bIns="4641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23608" y="3373754"/>
            <a:ext cx="7388860" cy="2760346"/>
          </a:xfrm>
          <a:prstGeom prst="rect">
            <a:avLst/>
          </a:prstGeom>
        </p:spPr>
        <p:txBody>
          <a:bodyPr vert="horz" lIns="92830" tIns="46415" rIns="92830" bIns="46415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658664"/>
            <a:ext cx="4002299" cy="351736"/>
          </a:xfrm>
          <a:prstGeom prst="rect">
            <a:avLst/>
          </a:prstGeom>
        </p:spPr>
        <p:txBody>
          <a:bodyPr vert="horz" lIns="92830" tIns="46415" rIns="92830" bIns="4641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31639" y="6658664"/>
            <a:ext cx="4002299" cy="351736"/>
          </a:xfrm>
          <a:prstGeom prst="rect">
            <a:avLst/>
          </a:prstGeom>
        </p:spPr>
        <p:txBody>
          <a:bodyPr vert="horz" lIns="92830" tIns="46415" rIns="92830" bIns="46415" rtlCol="0" anchor="b"/>
          <a:lstStyle>
            <a:lvl1pPr algn="r">
              <a:defRPr sz="1200"/>
            </a:lvl1pPr>
          </a:lstStyle>
          <a:p>
            <a:fld id="{7CF0BAFB-C050-446A-8123-CA27693ED3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303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F0BAFB-C050-446A-8123-CA27693ED36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6718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F0BAFB-C050-446A-8123-CA27693ED36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2534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F0BAFB-C050-446A-8123-CA27693ED36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8924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F0BAFB-C050-446A-8123-CA27693ED36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74968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F0BAFB-C050-446A-8123-CA27693ED36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33762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F0BAFB-C050-446A-8123-CA27693ED36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00129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. S8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F0BAFB-C050-446A-8123-CA27693ED36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076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E3E8A-F7D0-4CA9-9435-EF26B18290F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3053E-6A30-4DCC-8B98-F223F5D9F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247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E3E8A-F7D0-4CA9-9435-EF26B18290F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3053E-6A30-4DCC-8B98-F223F5D9F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956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E3E8A-F7D0-4CA9-9435-EF26B18290F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3053E-6A30-4DCC-8B98-F223F5D9F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176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E3E8A-F7D0-4CA9-9435-EF26B18290F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3053E-6A30-4DCC-8B98-F223F5D9F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17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E3E8A-F7D0-4CA9-9435-EF26B18290F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3053E-6A30-4DCC-8B98-F223F5D9F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925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E3E8A-F7D0-4CA9-9435-EF26B18290F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3053E-6A30-4DCC-8B98-F223F5D9F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849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E3E8A-F7D0-4CA9-9435-EF26B18290F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3053E-6A30-4DCC-8B98-F223F5D9F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614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E3E8A-F7D0-4CA9-9435-EF26B18290F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3053E-6A30-4DCC-8B98-F223F5D9F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028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E3E8A-F7D0-4CA9-9435-EF26B18290F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3053E-6A30-4DCC-8B98-F223F5D9F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795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E3E8A-F7D0-4CA9-9435-EF26B18290F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3053E-6A30-4DCC-8B98-F223F5D9F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372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E3E8A-F7D0-4CA9-9435-EF26B18290F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3053E-6A30-4DCC-8B98-F223F5D9F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291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DE3E8A-F7D0-4CA9-9435-EF26B18290FF}" type="datetimeFigureOut">
              <a:rPr lang="en-US" smtClean="0"/>
              <a:t>6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B3053E-6A30-4DCC-8B98-F223F5D9F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779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4" Type="http://schemas.openxmlformats.org/officeDocument/2006/relationships/image" Target="../media/image2.jpeg"/><Relationship Id="rId9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6DEF7D-4213-4B11-80C0-0073EC7520D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NK1 Regulates Uterine Homeostasis and its Ability to Support Pregnancy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047192-4997-470F-90D6-07735E30075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s</a:t>
            </a:r>
          </a:p>
        </p:txBody>
      </p:sp>
    </p:spTree>
    <p:extLst>
      <p:ext uri="{BB962C8B-B14F-4D97-AF65-F5344CB8AC3E}">
        <p14:creationId xmlns:p14="http://schemas.microsoft.com/office/powerpoint/2010/main" val="27911850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008FDA80-1970-4D0D-8CDB-F3FBABF1656F}"/>
              </a:ext>
            </a:extLst>
          </p:cNvPr>
          <p:cNvCxnSpPr>
            <a:cxnSpLocks/>
          </p:cNvCxnSpPr>
          <p:nvPr/>
        </p:nvCxnSpPr>
        <p:spPr>
          <a:xfrm>
            <a:off x="183491" y="1955871"/>
            <a:ext cx="36576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38">
            <a:extLst>
              <a:ext uri="{FF2B5EF4-FFF2-40B4-BE49-F238E27FC236}">
                <a16:creationId xmlns:a16="http://schemas.microsoft.com/office/drawing/2014/main" id="{72D53924-4192-40EA-83AF-3A9CAE53D869}"/>
              </a:ext>
            </a:extLst>
          </p:cNvPr>
          <p:cNvSpPr/>
          <p:nvPr/>
        </p:nvSpPr>
        <p:spPr>
          <a:xfrm>
            <a:off x="372727" y="1780641"/>
            <a:ext cx="1188720" cy="29576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1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150090F8-F974-4C0F-B759-5DB608CAEA83}"/>
              </a:ext>
            </a:extLst>
          </p:cNvPr>
          <p:cNvSpPr/>
          <p:nvPr/>
        </p:nvSpPr>
        <p:spPr>
          <a:xfrm>
            <a:off x="2234110" y="1780640"/>
            <a:ext cx="371114" cy="29576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2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B2A208E4-E575-43F6-9F38-C1B5372EBAEC}"/>
              </a:ext>
            </a:extLst>
          </p:cNvPr>
          <p:cNvSpPr/>
          <p:nvPr/>
        </p:nvSpPr>
        <p:spPr>
          <a:xfrm>
            <a:off x="3194615" y="1780639"/>
            <a:ext cx="371114" cy="29576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3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D8738701-F101-43F4-8B78-696CFCCACB7B}"/>
              </a:ext>
            </a:extLst>
          </p:cNvPr>
          <p:cNvCxnSpPr/>
          <p:nvPr/>
        </p:nvCxnSpPr>
        <p:spPr>
          <a:xfrm>
            <a:off x="4164032" y="1955871"/>
            <a:ext cx="1371600" cy="0"/>
          </a:xfrm>
          <a:prstGeom prst="line">
            <a:avLst/>
          </a:prstGeom>
          <a:ln w="762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B5327380-1804-4957-BEB4-F7DAFCF12A30}"/>
              </a:ext>
            </a:extLst>
          </p:cNvPr>
          <p:cNvSpPr/>
          <p:nvPr/>
        </p:nvSpPr>
        <p:spPr>
          <a:xfrm>
            <a:off x="1911247" y="1644489"/>
            <a:ext cx="181429" cy="514350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L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396FA7E-3F53-45FB-8D2A-271D527AD130}"/>
              </a:ext>
            </a:extLst>
          </p:cNvPr>
          <p:cNvSpPr/>
          <p:nvPr/>
        </p:nvSpPr>
        <p:spPr>
          <a:xfrm>
            <a:off x="2746469" y="1644489"/>
            <a:ext cx="181429" cy="514350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L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60812E9-1306-47FB-87E3-AD20A920F91E}"/>
              </a:ext>
            </a:extLst>
          </p:cNvPr>
          <p:cNvSpPr txBox="1"/>
          <p:nvPr/>
        </p:nvSpPr>
        <p:spPr>
          <a:xfrm>
            <a:off x="5626443" y="1728865"/>
            <a:ext cx="15926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Wnk1</a:t>
            </a:r>
            <a:r>
              <a:rPr lang="en-US" sz="2400" baseline="30000" dirty="0"/>
              <a:t>f/f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9AF85181-5584-47DC-82ED-E9A2E284E295}"/>
              </a:ext>
            </a:extLst>
          </p:cNvPr>
          <p:cNvCxnSpPr>
            <a:cxnSpLocks/>
          </p:cNvCxnSpPr>
          <p:nvPr/>
        </p:nvCxnSpPr>
        <p:spPr>
          <a:xfrm>
            <a:off x="183491" y="2983243"/>
            <a:ext cx="36576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90351E88-F043-41CB-BF55-A82E16B0C722}"/>
              </a:ext>
            </a:extLst>
          </p:cNvPr>
          <p:cNvSpPr/>
          <p:nvPr/>
        </p:nvSpPr>
        <p:spPr>
          <a:xfrm>
            <a:off x="372727" y="2820595"/>
            <a:ext cx="1188720" cy="29576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1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C9FAB531-006F-437D-91C3-CA7C142D8450}"/>
              </a:ext>
            </a:extLst>
          </p:cNvPr>
          <p:cNvSpPr/>
          <p:nvPr/>
        </p:nvSpPr>
        <p:spPr>
          <a:xfrm>
            <a:off x="2943106" y="2820595"/>
            <a:ext cx="371114" cy="29576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3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4668E554-554B-4739-B20D-CDB1B2588F39}"/>
              </a:ext>
            </a:extLst>
          </p:cNvPr>
          <p:cNvCxnSpPr/>
          <p:nvPr/>
        </p:nvCxnSpPr>
        <p:spPr>
          <a:xfrm>
            <a:off x="3808432" y="2983243"/>
            <a:ext cx="1371600" cy="0"/>
          </a:xfrm>
          <a:prstGeom prst="line">
            <a:avLst/>
          </a:prstGeom>
          <a:ln w="762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AutoShape 2" descr="Image result for scissors sign">
            <a:extLst>
              <a:ext uri="{FF2B5EF4-FFF2-40B4-BE49-F238E27FC236}">
                <a16:creationId xmlns:a16="http://schemas.microsoft.com/office/drawing/2014/main" id="{EFAC584A-D642-4DB6-A880-FBA70611DCED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3604118" y="300757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A65E30D-A88D-401A-846B-0F4FACC8BB27}"/>
              </a:ext>
            </a:extLst>
          </p:cNvPr>
          <p:cNvSpPr txBox="1"/>
          <p:nvPr/>
        </p:nvSpPr>
        <p:spPr>
          <a:xfrm>
            <a:off x="5264648" y="2750428"/>
            <a:ext cx="15926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Wnk1</a:t>
            </a:r>
            <a:r>
              <a:rPr lang="en-US" sz="2400" baseline="30000" dirty="0"/>
              <a:t>d/d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E8D767DC-B82E-4C48-A24B-FCA1357F0A88}"/>
              </a:ext>
            </a:extLst>
          </p:cNvPr>
          <p:cNvSpPr/>
          <p:nvPr/>
        </p:nvSpPr>
        <p:spPr>
          <a:xfrm>
            <a:off x="3835616" y="1780638"/>
            <a:ext cx="371114" cy="29576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4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3BA3282C-4BE0-490A-BB99-BB9B6B5653A8}"/>
              </a:ext>
            </a:extLst>
          </p:cNvPr>
          <p:cNvSpPr/>
          <p:nvPr/>
        </p:nvSpPr>
        <p:spPr>
          <a:xfrm>
            <a:off x="3584107" y="2820594"/>
            <a:ext cx="371114" cy="29576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4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8A723A08-14CA-49A3-B904-4B01BD5091EB}"/>
              </a:ext>
            </a:extLst>
          </p:cNvPr>
          <p:cNvCxnSpPr>
            <a:cxnSpLocks/>
            <a:stCxn id="43" idx="2"/>
          </p:cNvCxnSpPr>
          <p:nvPr/>
        </p:nvCxnSpPr>
        <p:spPr>
          <a:xfrm>
            <a:off x="2001962" y="2158839"/>
            <a:ext cx="0" cy="773483"/>
          </a:xfrm>
          <a:prstGeom prst="line">
            <a:avLst/>
          </a:prstGeom>
          <a:ln w="1905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7844647E-F12C-4DCB-83F4-879FF0B5ED71}"/>
              </a:ext>
            </a:extLst>
          </p:cNvPr>
          <p:cNvCxnSpPr>
            <a:cxnSpLocks/>
            <a:stCxn id="44" idx="2"/>
          </p:cNvCxnSpPr>
          <p:nvPr/>
        </p:nvCxnSpPr>
        <p:spPr>
          <a:xfrm flipH="1">
            <a:off x="1989920" y="2158839"/>
            <a:ext cx="847264" cy="808928"/>
          </a:xfrm>
          <a:prstGeom prst="line">
            <a:avLst/>
          </a:prstGeom>
          <a:ln w="1905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6" name="Picture 4" descr="Scissor K Clip Art">
            <a:extLst>
              <a:ext uri="{FF2B5EF4-FFF2-40B4-BE49-F238E27FC236}">
                <a16:creationId xmlns:a16="http://schemas.microsoft.com/office/drawing/2014/main" id="{93C5CA0F-6EBA-46BE-9DB7-721E6463C86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147165">
            <a:off x="2184163" y="2373835"/>
            <a:ext cx="499184" cy="552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57" name="Group 56">
            <a:extLst>
              <a:ext uri="{FF2B5EF4-FFF2-40B4-BE49-F238E27FC236}">
                <a16:creationId xmlns:a16="http://schemas.microsoft.com/office/drawing/2014/main" id="{3569A4B4-2E99-4E81-83CD-66D3F126C9F7}"/>
              </a:ext>
            </a:extLst>
          </p:cNvPr>
          <p:cNvGrpSpPr/>
          <p:nvPr/>
        </p:nvGrpSpPr>
        <p:grpSpPr>
          <a:xfrm>
            <a:off x="2864672" y="2166440"/>
            <a:ext cx="1478892" cy="593173"/>
            <a:chOff x="5808986" y="2364279"/>
            <a:chExt cx="3051606" cy="1223977"/>
          </a:xfrm>
        </p:grpSpPr>
        <p:pic>
          <p:nvPicPr>
            <p:cNvPr id="58" name="Picture 6" descr="https://thumbs.dreamstime.com/z/mouse-sketch-11980711.jpg">
              <a:extLst>
                <a:ext uri="{FF2B5EF4-FFF2-40B4-BE49-F238E27FC236}">
                  <a16:creationId xmlns:a16="http://schemas.microsoft.com/office/drawing/2014/main" id="{030D70DE-DCA7-467E-BF3A-F74DFC14953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92" t="8057" r="4112" b="22078"/>
            <a:stretch/>
          </p:blipFill>
          <p:spPr bwMode="auto">
            <a:xfrm>
              <a:off x="5808986" y="2364279"/>
              <a:ext cx="3051606" cy="122397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42115B20-E6AF-4757-84E8-8CC3BC427167}"/>
                </a:ext>
              </a:extLst>
            </p:cNvPr>
            <p:cNvSpPr txBox="1"/>
            <p:nvPr/>
          </p:nvSpPr>
          <p:spPr>
            <a:xfrm>
              <a:off x="6270776" y="2765509"/>
              <a:ext cx="1548841" cy="508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err="1"/>
                <a:t>PGR</a:t>
              </a:r>
              <a:r>
                <a:rPr lang="en-US" sz="1000" dirty="0" err="1"/>
                <a:t>Cre</a:t>
              </a:r>
              <a:endParaRPr lang="en-US" sz="1000" dirty="0"/>
            </a:p>
          </p:txBody>
        </p:sp>
      </p:grpSp>
      <p:pic>
        <p:nvPicPr>
          <p:cNvPr id="60" name="Picture 59">
            <a:extLst>
              <a:ext uri="{FF2B5EF4-FFF2-40B4-BE49-F238E27FC236}">
                <a16:creationId xmlns:a16="http://schemas.microsoft.com/office/drawing/2014/main" id="{7FE88A89-1D57-44CE-9DCC-B3A5DBECDE0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l="57720" t="26993" r="27996" b="70149"/>
          <a:stretch/>
        </p:blipFill>
        <p:spPr>
          <a:xfrm>
            <a:off x="4088329" y="4640395"/>
            <a:ext cx="1819656" cy="22437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73D85148-9DBE-4565-A4A3-63EF1C12C7B9}"/>
              </a:ext>
            </a:extLst>
          </p:cNvPr>
          <p:cNvSpPr txBox="1"/>
          <p:nvPr/>
        </p:nvSpPr>
        <p:spPr>
          <a:xfrm>
            <a:off x="3233041" y="4569989"/>
            <a:ext cx="842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WNK1</a:t>
            </a:r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272CFA63-C78B-471A-8BB7-90F770C46D6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39" t="22204" r="388" b="21307"/>
          <a:stretch/>
        </p:blipFill>
        <p:spPr>
          <a:xfrm>
            <a:off x="4084294" y="4991529"/>
            <a:ext cx="1823691" cy="26817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4918147E-E6B3-466D-8EEC-39AEA2C6DC73}"/>
              </a:ext>
            </a:extLst>
          </p:cNvPr>
          <p:cNvSpPr txBox="1"/>
          <p:nvPr/>
        </p:nvSpPr>
        <p:spPr>
          <a:xfrm>
            <a:off x="2888994" y="4942833"/>
            <a:ext cx="11868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GAPDH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C15DBE99-A2BF-46AC-8DCA-FA1B7E22181F}"/>
              </a:ext>
            </a:extLst>
          </p:cNvPr>
          <p:cNvCxnSpPr/>
          <p:nvPr/>
        </p:nvCxnSpPr>
        <p:spPr>
          <a:xfrm>
            <a:off x="4233560" y="4523213"/>
            <a:ext cx="579727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EB1221D1-8E0B-4ABF-85F9-895F98C638A8}"/>
              </a:ext>
            </a:extLst>
          </p:cNvPr>
          <p:cNvCxnSpPr/>
          <p:nvPr/>
        </p:nvCxnSpPr>
        <p:spPr>
          <a:xfrm>
            <a:off x="5157033" y="4514546"/>
            <a:ext cx="579727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B37B00AD-6912-4A06-9F99-51B483FE61B9}"/>
              </a:ext>
            </a:extLst>
          </p:cNvPr>
          <p:cNvSpPr txBox="1"/>
          <p:nvPr/>
        </p:nvSpPr>
        <p:spPr>
          <a:xfrm>
            <a:off x="4968279" y="4185195"/>
            <a:ext cx="8897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Wnk1</a:t>
            </a:r>
            <a:r>
              <a:rPr lang="en-US" sz="1600" baseline="30000" dirty="0"/>
              <a:t>d/d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E0348AB-18CA-4E6E-A180-14F755AEF824}"/>
              </a:ext>
            </a:extLst>
          </p:cNvPr>
          <p:cNvSpPr txBox="1"/>
          <p:nvPr/>
        </p:nvSpPr>
        <p:spPr>
          <a:xfrm>
            <a:off x="4078567" y="4179430"/>
            <a:ext cx="8897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Wnk1</a:t>
            </a:r>
            <a:r>
              <a:rPr lang="en-US" sz="1600" baseline="30000" dirty="0"/>
              <a:t>f/f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1089AFB-6B7F-4B96-B779-DA0CA9DF2F2B}"/>
              </a:ext>
            </a:extLst>
          </p:cNvPr>
          <p:cNvSpPr txBox="1"/>
          <p:nvPr/>
        </p:nvSpPr>
        <p:spPr>
          <a:xfrm>
            <a:off x="267372" y="1154000"/>
            <a:ext cx="487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BEA1C81-348C-46C7-922F-33EF81374A03}"/>
              </a:ext>
            </a:extLst>
          </p:cNvPr>
          <p:cNvSpPr txBox="1"/>
          <p:nvPr/>
        </p:nvSpPr>
        <p:spPr>
          <a:xfrm>
            <a:off x="325139" y="3658336"/>
            <a:ext cx="487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1540160-B5D5-4FC2-82BC-9BEDFA547BA1}"/>
              </a:ext>
            </a:extLst>
          </p:cNvPr>
          <p:cNvSpPr txBox="1"/>
          <p:nvPr/>
        </p:nvSpPr>
        <p:spPr>
          <a:xfrm>
            <a:off x="2997058" y="3703323"/>
            <a:ext cx="487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pic>
        <p:nvPicPr>
          <p:cNvPr id="71" name="Picture 70">
            <a:extLst>
              <a:ext uri="{FF2B5EF4-FFF2-40B4-BE49-F238E27FC236}">
                <a16:creationId xmlns:a16="http://schemas.microsoft.com/office/drawing/2014/main" id="{D4A39301-981B-4656-9670-2E2B84B9222D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11949" b="13090"/>
          <a:stretch/>
        </p:blipFill>
        <p:spPr>
          <a:xfrm>
            <a:off x="658599" y="4010615"/>
            <a:ext cx="1832214" cy="2207263"/>
          </a:xfrm>
          <a:prstGeom prst="rect">
            <a:avLst/>
          </a:prstGeom>
        </p:spPr>
      </p:pic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C957A31C-2BC8-4226-93D8-CA7911757203}"/>
              </a:ext>
            </a:extLst>
          </p:cNvPr>
          <p:cNvCxnSpPr/>
          <p:nvPr/>
        </p:nvCxnSpPr>
        <p:spPr>
          <a:xfrm>
            <a:off x="2047240" y="1505712"/>
            <a:ext cx="268224" cy="0"/>
          </a:xfrm>
          <a:prstGeom prst="line">
            <a:avLst/>
          </a:prstGeom>
          <a:ln w="381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C74D13F9-C3CC-48C4-A757-1A353DF23AEA}"/>
              </a:ext>
            </a:extLst>
          </p:cNvPr>
          <p:cNvCxnSpPr>
            <a:cxnSpLocks/>
          </p:cNvCxnSpPr>
          <p:nvPr/>
        </p:nvCxnSpPr>
        <p:spPr>
          <a:xfrm flipH="1">
            <a:off x="2481493" y="1505712"/>
            <a:ext cx="268224" cy="0"/>
          </a:xfrm>
          <a:prstGeom prst="line">
            <a:avLst/>
          </a:prstGeom>
          <a:ln w="381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36A4C9B0-8AF5-41A1-ADA5-7F17E6B4DC6B}"/>
              </a:ext>
            </a:extLst>
          </p:cNvPr>
          <p:cNvSpPr txBox="1"/>
          <p:nvPr/>
        </p:nvSpPr>
        <p:spPr>
          <a:xfrm>
            <a:off x="0" y="0"/>
            <a:ext cx="2416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39073827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CEAEE334-9078-485C-8BC3-D02E8C6702E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1341" b="12155"/>
          <a:stretch/>
        </p:blipFill>
        <p:spPr>
          <a:xfrm>
            <a:off x="2030913" y="6594831"/>
            <a:ext cx="2568266" cy="236123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8BDC5B2-1750-4702-88B7-DE3674A50BE4}"/>
              </a:ext>
            </a:extLst>
          </p:cNvPr>
          <p:cNvSpPr txBox="1"/>
          <p:nvPr/>
        </p:nvSpPr>
        <p:spPr>
          <a:xfrm>
            <a:off x="1521841" y="914761"/>
            <a:ext cx="487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86BA772-BF62-465B-BDC8-11B23FDE9F2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2875" b="11746"/>
          <a:stretch/>
        </p:blipFill>
        <p:spPr>
          <a:xfrm>
            <a:off x="2004239" y="1190568"/>
            <a:ext cx="2621613" cy="232651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5BB16D3-60D7-49B2-957C-8B4CAF3A0BE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1509" b="11987"/>
          <a:stretch/>
        </p:blipFill>
        <p:spPr>
          <a:xfrm>
            <a:off x="2030913" y="3875337"/>
            <a:ext cx="2652097" cy="236123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0486CEA-542D-49E7-8EE0-F802BACE03B7}"/>
              </a:ext>
            </a:extLst>
          </p:cNvPr>
          <p:cNvSpPr txBox="1"/>
          <p:nvPr/>
        </p:nvSpPr>
        <p:spPr>
          <a:xfrm>
            <a:off x="1521841" y="6357964"/>
            <a:ext cx="487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434FADD-4680-4218-84F7-E00BB8DA40C8}"/>
              </a:ext>
            </a:extLst>
          </p:cNvPr>
          <p:cNvSpPr txBox="1"/>
          <p:nvPr/>
        </p:nvSpPr>
        <p:spPr>
          <a:xfrm>
            <a:off x="0" y="0"/>
            <a:ext cx="2416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7377C32-276B-4E9C-94F7-9660D4580538}"/>
              </a:ext>
            </a:extLst>
          </p:cNvPr>
          <p:cNvSpPr txBox="1"/>
          <p:nvPr/>
        </p:nvSpPr>
        <p:spPr>
          <a:xfrm>
            <a:off x="1521841" y="3747001"/>
            <a:ext cx="487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734684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7F71CCE-56A6-4338-A802-47B12BDAAF3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2799" y="1858344"/>
            <a:ext cx="4137053" cy="404114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233E295-5BA8-447A-9E0F-87A610884F0A}"/>
              </a:ext>
            </a:extLst>
          </p:cNvPr>
          <p:cNvSpPr txBox="1"/>
          <p:nvPr/>
        </p:nvSpPr>
        <p:spPr>
          <a:xfrm>
            <a:off x="0" y="0"/>
            <a:ext cx="2416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81040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53">
            <a:extLst>
              <a:ext uri="{FF2B5EF4-FFF2-40B4-BE49-F238E27FC236}">
                <a16:creationId xmlns:a16="http://schemas.microsoft.com/office/drawing/2014/main" id="{BF74DC14-BE6E-4C96-9E53-A03DC632804D}"/>
              </a:ext>
            </a:extLst>
          </p:cNvPr>
          <p:cNvSpPr txBox="1"/>
          <p:nvPr/>
        </p:nvSpPr>
        <p:spPr>
          <a:xfrm>
            <a:off x="0" y="0"/>
            <a:ext cx="2416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1C6F9C5C-E153-4FD8-9636-B4C3A34A70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49" t="36852" r="4291" b="7191"/>
          <a:stretch/>
        </p:blipFill>
        <p:spPr>
          <a:xfrm>
            <a:off x="289560" y="1544215"/>
            <a:ext cx="6278880" cy="278892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D0BE8114-7954-484B-AA29-0303E05E1BA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4682" r="8024" b="85470"/>
          <a:stretch/>
        </p:blipFill>
        <p:spPr>
          <a:xfrm>
            <a:off x="5496560" y="1182132"/>
            <a:ext cx="1153160" cy="724166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44FB6897-A696-4C21-B0CF-C20BACD311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9560" y="4406834"/>
            <a:ext cx="5302053" cy="458267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202A92B-B4F9-48FA-970C-21DD6D21BF02}"/>
              </a:ext>
            </a:extLst>
          </p:cNvPr>
          <p:cNvSpPr txBox="1"/>
          <p:nvPr/>
        </p:nvSpPr>
        <p:spPr>
          <a:xfrm>
            <a:off x="45720" y="1270062"/>
            <a:ext cx="487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EA9C5AB-F286-4424-9592-2F1E30ED875E}"/>
              </a:ext>
            </a:extLst>
          </p:cNvPr>
          <p:cNvSpPr txBox="1"/>
          <p:nvPr/>
        </p:nvSpPr>
        <p:spPr>
          <a:xfrm>
            <a:off x="45720" y="4102302"/>
            <a:ext cx="487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669313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Picture 77">
            <a:extLst>
              <a:ext uri="{FF2B5EF4-FFF2-40B4-BE49-F238E27FC236}">
                <a16:creationId xmlns:a16="http://schemas.microsoft.com/office/drawing/2014/main" id="{16586C6E-410D-4E3B-B2FE-44FF57B19F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6644" y="5255686"/>
            <a:ext cx="3231240" cy="3247237"/>
          </a:xfrm>
          <a:prstGeom prst="rect">
            <a:avLst/>
          </a:prstGeom>
        </p:spPr>
      </p:pic>
      <p:sp>
        <p:nvSpPr>
          <p:cNvPr id="101" name="TextBox 100">
            <a:extLst>
              <a:ext uri="{FF2B5EF4-FFF2-40B4-BE49-F238E27FC236}">
                <a16:creationId xmlns:a16="http://schemas.microsoft.com/office/drawing/2014/main" id="{8109BD1F-DC96-4FC1-A4B2-903B22505B15}"/>
              </a:ext>
            </a:extLst>
          </p:cNvPr>
          <p:cNvSpPr txBox="1"/>
          <p:nvPr/>
        </p:nvSpPr>
        <p:spPr>
          <a:xfrm>
            <a:off x="592886" y="1349445"/>
            <a:ext cx="487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97FDC928-F29E-4D48-8BDE-567C3D08FC09}"/>
              </a:ext>
            </a:extLst>
          </p:cNvPr>
          <p:cNvSpPr txBox="1"/>
          <p:nvPr/>
        </p:nvSpPr>
        <p:spPr>
          <a:xfrm>
            <a:off x="310925" y="5177253"/>
            <a:ext cx="487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BAC68DCE-A860-4BCA-B62A-DFD06A036DA9}"/>
              </a:ext>
            </a:extLst>
          </p:cNvPr>
          <p:cNvSpPr txBox="1"/>
          <p:nvPr/>
        </p:nvSpPr>
        <p:spPr>
          <a:xfrm>
            <a:off x="3755483" y="5177253"/>
            <a:ext cx="487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DEFAA155-9C10-4FB7-8B5E-522C83C9B46F}"/>
              </a:ext>
            </a:extLst>
          </p:cNvPr>
          <p:cNvSpPr txBox="1"/>
          <p:nvPr/>
        </p:nvSpPr>
        <p:spPr>
          <a:xfrm>
            <a:off x="0" y="0"/>
            <a:ext cx="2416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pic>
        <p:nvPicPr>
          <p:cNvPr id="106" name="Picture 105">
            <a:extLst>
              <a:ext uri="{FF2B5EF4-FFF2-40B4-BE49-F238E27FC236}">
                <a16:creationId xmlns:a16="http://schemas.microsoft.com/office/drawing/2014/main" id="{B82A6099-D756-4657-9D7A-A236E0B9EFB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5037" y="1580277"/>
            <a:ext cx="5047926" cy="343844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CD967A58-1A49-4F06-AAB0-01732875E0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55483" y="5486518"/>
            <a:ext cx="2743438" cy="27922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62664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7FB69EF-C13B-4A0A-9CAD-5B788E81DFF1}"/>
              </a:ext>
            </a:extLst>
          </p:cNvPr>
          <p:cNvSpPr txBox="1"/>
          <p:nvPr/>
        </p:nvSpPr>
        <p:spPr>
          <a:xfrm>
            <a:off x="0" y="0"/>
            <a:ext cx="2416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5253FE8-89A1-4A80-9ADD-477B4CA9CB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9102" y="1929667"/>
            <a:ext cx="1688738" cy="3853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86910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15DBFF4-70B9-4CF8-9771-786ED7FFF500}"/>
              </a:ext>
            </a:extLst>
          </p:cNvPr>
          <p:cNvSpPr txBox="1"/>
          <p:nvPr/>
        </p:nvSpPr>
        <p:spPr>
          <a:xfrm>
            <a:off x="0" y="0"/>
            <a:ext cx="2416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5B9B4C9-8E42-4EBD-B56F-7C563129358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419" r="3807" b="5938"/>
          <a:stretch/>
        </p:blipFill>
        <p:spPr>
          <a:xfrm>
            <a:off x="1494692" y="2253641"/>
            <a:ext cx="4713748" cy="40885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0781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42</TotalTime>
  <Words>72</Words>
  <Application>Microsoft Office PowerPoint</Application>
  <PresentationFormat>A4 Paper (210x297 mm)</PresentationFormat>
  <Paragraphs>44</Paragraphs>
  <Slides>8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WNK1 Regulates Uterine Homeostasis and its Ability to Support Pregnancy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terine Functions of WNK1: Regulation of epithelial proliferation and implantation through AKT-FOXO1 signaling</dc:title>
  <dc:creator>Chi, Ru-Pin (NIH/NIEHS) [F]</dc:creator>
  <cp:lastModifiedBy>Chi, Ru-Pin (NIH/NIEHS) [F]</cp:lastModifiedBy>
  <cp:revision>44</cp:revision>
  <cp:lastPrinted>2020-01-02T22:48:18Z</cp:lastPrinted>
  <dcterms:created xsi:type="dcterms:W3CDTF">2019-11-26T23:54:20Z</dcterms:created>
  <dcterms:modified xsi:type="dcterms:W3CDTF">2020-06-24T20:44:40Z</dcterms:modified>
</cp:coreProperties>
</file>